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53" y="4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05F5EA-2F4D-442A-8FF7-98C11D0D64F4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6B2E57-38DE-48E3-979E-146E20FACD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643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481C4A-934E-494B-8C91-20899C5818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1611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983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34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282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115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043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33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84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566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044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16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950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E34DE-32DC-453B-9DE2-845FDCBB82C0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B81DD-E099-4690-B22F-F9975A109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448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95436" y="418430"/>
            <a:ext cx="26303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UPPLEMENTAL </a:t>
            </a:r>
            <a:r>
              <a:rPr lang="en-US" b="1" smtClean="0"/>
              <a:t>FIGURE </a:t>
            </a:r>
            <a:r>
              <a:rPr lang="en-US" b="1" smtClean="0"/>
              <a:t>7</a:t>
            </a:r>
            <a:endParaRPr lang="en-US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5800"/>
          <a:stretch/>
        </p:blipFill>
        <p:spPr>
          <a:xfrm>
            <a:off x="4892879" y="2112714"/>
            <a:ext cx="3667093" cy="292779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6290"/>
          <a:stretch/>
        </p:blipFill>
        <p:spPr>
          <a:xfrm>
            <a:off x="8714124" y="2023671"/>
            <a:ext cx="3322755" cy="310588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7008624" y="1443386"/>
            <a:ext cx="434329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Sample clustering to detect outliers</a:t>
            </a:r>
            <a:endParaRPr lang="en-US" dirty="0"/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1194442"/>
              </p:ext>
            </p:extLst>
          </p:nvPr>
        </p:nvGraphicFramePr>
        <p:xfrm>
          <a:off x="395436" y="2807007"/>
          <a:ext cx="3996181" cy="2079455"/>
        </p:xfrm>
        <a:graphic>
          <a:graphicData uri="http://schemas.openxmlformats.org/drawingml/2006/table">
            <a:tbl>
              <a:tblPr/>
              <a:tblGrid>
                <a:gridCol w="935691"/>
                <a:gridCol w="935691"/>
                <a:gridCol w="935691"/>
                <a:gridCol w="1189108"/>
              </a:tblGrid>
              <a:tr h="6931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umber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w 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number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/no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3465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w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1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65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w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2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65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w3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3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657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ow4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st4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395436" y="1443386"/>
            <a:ext cx="434329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Fish weight of slow and fast/normal growers. Muscle samples were taken for RNA extraction and subsequently </a:t>
            </a:r>
            <a:r>
              <a:rPr lang="en-US" b="1" dirty="0" err="1" smtClean="0">
                <a:solidFill>
                  <a:srgbClr val="000000"/>
                </a:solidFill>
                <a:cs typeface="Times New Roman" panose="02020603050405020304" pitchFamily="18" charset="0"/>
              </a:rPr>
              <a:t>RNAseq</a:t>
            </a:r>
            <a:r>
              <a:rPr lang="en-US" b="1" dirty="0" smtClean="0">
                <a:solidFill>
                  <a:srgbClr val="000000"/>
                </a:solidFill>
                <a:cs typeface="Times New Roman" panose="02020603050405020304" pitchFamily="18" charset="0"/>
              </a:rPr>
              <a:t> analysis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 rot="16200000">
            <a:off x="4962644" y="2594252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5858512" y="4926124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5392044" y="3792553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9008853" y="3419698"/>
            <a:ext cx="475462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72000" tIns="0" rIns="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9369646" y="4926122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Ins="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6321279" y="4926123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9852109" y="4935362"/>
            <a:ext cx="533294" cy="276999"/>
          </a:xfrm>
          <a:prstGeom prst="rect">
            <a:avLst/>
          </a:prstGeom>
          <a:solidFill>
            <a:schemeClr val="bg1"/>
          </a:solidFill>
        </p:spPr>
        <p:txBody>
          <a:bodyPr wrap="square" rIns="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st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7183969" y="4347713"/>
            <a:ext cx="645322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10783655" y="4064782"/>
            <a:ext cx="484664" cy="18466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36000" bIns="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4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10305338" y="2618022"/>
            <a:ext cx="484664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rIns="3600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6817800" y="3283028"/>
            <a:ext cx="484664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3600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3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11248628" y="4585045"/>
            <a:ext cx="484664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rIns="3600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7758297" y="4605892"/>
            <a:ext cx="430875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tIns="36000" rIns="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1656664" y="4578997"/>
            <a:ext cx="484664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rIns="3600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8167254" y="4632785"/>
            <a:ext cx="484664" cy="278089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bIns="46800" rtlCol="0">
            <a:spAutoFit/>
          </a:bodyPr>
          <a:lstStyle/>
          <a:p>
            <a:pPr algn="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ow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0349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3</Words>
  <Application>Microsoft Office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</dc:creator>
  <cp:lastModifiedBy>Elena</cp:lastModifiedBy>
  <cp:revision>8</cp:revision>
  <dcterms:created xsi:type="dcterms:W3CDTF">2017-05-12T12:20:20Z</dcterms:created>
  <dcterms:modified xsi:type="dcterms:W3CDTF">2017-08-09T15:33:01Z</dcterms:modified>
</cp:coreProperties>
</file>